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798E32-ECE3-4408-A38F-7F806D3357B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6A97AE-5696-4FDA-90F3-CCDB4B21C83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085F67-B2F9-48A9-9E6B-3F456FDF50C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F5425F-969C-4D60-BC6C-E6BD00BD99E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493270-5EE2-4D17-8D34-2D3E3E2B361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631B1A-0233-4600-A473-AB368614FF5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8F22CC-BAC2-4EC3-BE24-CCA585A608F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593AAF-6836-43B0-9225-A19A4C9F9AB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A06A55-2EC1-49A5-994C-11E6DAC60DA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70D04F-1DCB-4A9D-B56C-178DBD3FDD9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DC6E8A-25E6-4E76-AA90-3C2B7A3179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EA4028-DDD9-4A2C-8176-D3EEC15FA57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401205B-486C-43D4-8696-69CB7E181AFF}" type="slidenum">
              <a:rPr b="0" lang="en-I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1.png"/><Relationship Id="rId6" Type="http://schemas.openxmlformats.org/officeDocument/2006/relationships/image" Target="../media/image2.png"/><Relationship Id="rId7" Type="http://schemas.openxmlformats.org/officeDocument/2006/relationships/image" Target="../media/image4.png"/><Relationship Id="rId8" Type="http://schemas.openxmlformats.org/officeDocument/2006/relationships/image" Target="../media/image4.png"/><Relationship Id="rId9" Type="http://schemas.openxmlformats.org/officeDocument/2006/relationships/image" Target="../media/image5.png"/><Relationship Id="rId1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"/>
          <p:cNvGrpSpPr/>
          <p:nvPr/>
        </p:nvGrpSpPr>
        <p:grpSpPr>
          <a:xfrm>
            <a:off x="907920" y="722520"/>
            <a:ext cx="5112000" cy="7422840"/>
            <a:chOff x="907920" y="722520"/>
            <a:chExt cx="5112000" cy="7422840"/>
          </a:xfrm>
        </p:grpSpPr>
        <p:grpSp>
          <p:nvGrpSpPr>
            <p:cNvPr id="42" name="Group 150"/>
            <p:cNvGrpSpPr/>
            <p:nvPr/>
          </p:nvGrpSpPr>
          <p:grpSpPr>
            <a:xfrm>
              <a:off x="1711440" y="722520"/>
              <a:ext cx="2093040" cy="1956600"/>
              <a:chOff x="1711440" y="722520"/>
              <a:chExt cx="2093040" cy="1956600"/>
            </a:xfrm>
          </p:grpSpPr>
          <p:grpSp>
            <p:nvGrpSpPr>
              <p:cNvPr id="43" name="Group 102"/>
              <p:cNvGrpSpPr/>
              <p:nvPr/>
            </p:nvGrpSpPr>
            <p:grpSpPr>
              <a:xfrm>
                <a:off x="1711440" y="722520"/>
                <a:ext cx="2093040" cy="1956600"/>
                <a:chOff x="1711440" y="722520"/>
                <a:chExt cx="2093040" cy="1956600"/>
              </a:xfrm>
            </p:grpSpPr>
            <p:sp>
              <p:nvSpPr>
                <p:cNvPr id="44" name="AutoShape 103"/>
                <p:cNvSpPr/>
                <p:nvPr/>
              </p:nvSpPr>
              <p:spPr>
                <a:xfrm rot="3456600">
                  <a:off x="1980720" y="991800"/>
                  <a:ext cx="1417680" cy="1417680"/>
                </a:xfrm>
                <a:custGeom>
                  <a:avLst/>
                  <a:gdLst>
                    <a:gd name="textAreaLeft" fmla="*/ 261720 w 1417680"/>
                    <a:gd name="textAreaRight" fmla="*/ 1155960 w 1417680"/>
                    <a:gd name="textAreaTop" fmla="*/ 0 h 1417680"/>
                    <a:gd name="textAreaBottom" fmla="*/ 263520 h 141768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6669" y="3098"/>
                      </a:moveTo>
                      <a:cubicBezTo>
                        <a:pt x="7939" y="2417"/>
                        <a:pt x="9358" y="2060"/>
                        <a:pt x="10800" y="2061"/>
                      </a:cubicBezTo>
                      <a:cubicBezTo>
                        <a:pt x="12241" y="2061"/>
                        <a:pt x="13660" y="2417"/>
                        <a:pt x="14930" y="3098"/>
                      </a:cubicBezTo>
                      <a:lnTo>
                        <a:pt x="15904" y="1282"/>
                      </a:lnTo>
                      <a:cubicBezTo>
                        <a:pt x="14334" y="440"/>
                        <a:pt x="12581" y="-1"/>
                        <a:pt x="10799" y="0"/>
                      </a:cubicBezTo>
                      <a:cubicBezTo>
                        <a:pt x="9018" y="0"/>
                        <a:pt x="7265" y="440"/>
                        <a:pt x="5695" y="1282"/>
                      </a:cubicBezTo>
                      <a:lnTo>
                        <a:pt x="6669" y="3098"/>
                      </a:lnTo>
                      <a:close/>
                    </a:path>
                  </a:pathLst>
                </a:custGeom>
                <a:blipFill rotWithShape="0">
                  <a:blip r:embed="rId1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" name="AutoShape 104"/>
                <p:cNvSpPr/>
                <p:nvPr/>
              </p:nvSpPr>
              <p:spPr>
                <a:xfrm>
                  <a:off x="1981080" y="992160"/>
                  <a:ext cx="1417680" cy="1417680"/>
                </a:xfrm>
                <a:custGeom>
                  <a:avLst/>
                  <a:gdLst>
                    <a:gd name="textAreaLeft" fmla="*/ 207720 w 1417680"/>
                    <a:gd name="textAreaRight" fmla="*/ 1209960 w 1417680"/>
                    <a:gd name="textAreaTop" fmla="*/ 207720 h 1417680"/>
                    <a:gd name="textAreaBottom" fmla="*/ 1209960 h 141768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10800"/>
                      </a:moveTo>
                      <a:cubicBezTo>
                        <a:pt x="0" y="4835"/>
                        <a:pt x="4835" y="0"/>
                        <a:pt x="10800" y="0"/>
                      </a:cubicBezTo>
                      <a:cubicBezTo>
                        <a:pt x="16765" y="0"/>
                        <a:pt x="21600" y="4835"/>
                        <a:pt x="21600" y="10800"/>
                      </a:cubicBezTo>
                      <a:cubicBezTo>
                        <a:pt x="21600" y="16765"/>
                        <a:pt x="16765" y="21600"/>
                        <a:pt x="10800" y="21600"/>
                      </a:cubicBezTo>
                      <a:cubicBezTo>
                        <a:pt x="4835" y="21600"/>
                        <a:pt x="0" y="16765"/>
                        <a:pt x="0" y="10800"/>
                      </a:cubicBezTo>
                      <a:close/>
                      <a:moveTo>
                        <a:pt x="2077" y="10800"/>
                      </a:moveTo>
                      <a:cubicBezTo>
                        <a:pt x="2077" y="15618"/>
                        <a:pt x="5982" y="19523"/>
                        <a:pt x="10800" y="19523"/>
                      </a:cubicBezTo>
                      <a:cubicBezTo>
                        <a:pt x="15618" y="19523"/>
                        <a:pt x="19523" y="15618"/>
                        <a:pt x="19523" y="10800"/>
                      </a:cubicBezTo>
                      <a:cubicBezTo>
                        <a:pt x="19523" y="5982"/>
                        <a:pt x="15618" y="2077"/>
                        <a:pt x="10800" y="2077"/>
                      </a:cubicBezTo>
                      <a:cubicBezTo>
                        <a:pt x="5982" y="2077"/>
                        <a:pt x="2077" y="5982"/>
                        <a:pt x="2077" y="10800"/>
                      </a:cubicBezTo>
                      <a:close/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" name="AutoShape 105"/>
                <p:cNvSpPr/>
                <p:nvPr/>
              </p:nvSpPr>
              <p:spPr>
                <a:xfrm>
                  <a:off x="1981080" y="992160"/>
                  <a:ext cx="1417680" cy="1417680"/>
                </a:xfrm>
                <a:prstGeom prst="pie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10800" bIns="46800" anchor="t" anchorCtr="1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Times New Roman"/>
                      <a:ea typeface="Arial"/>
                    </a:rPr>
                    <a:t>myco-</a:t>
                  </a:r>
                  <a:r>
                    <a:rPr b="0" i="1" lang="en-US" sz="800" spc="-1" strike="noStrike">
                      <a:solidFill>
                        <a:srgbClr val="000000"/>
                      </a:solidFill>
                      <a:latin typeface="Times New Roman"/>
                      <a:ea typeface="Arial"/>
                    </a:rPr>
                    <a:t>oriC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" name="Line 106"/>
                <p:cNvSpPr/>
                <p:nvPr/>
              </p:nvSpPr>
              <p:spPr>
                <a:xfrm>
                  <a:off x="3047760" y="1087560"/>
                  <a:ext cx="14760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" name="Line 107"/>
                <p:cNvSpPr/>
                <p:nvPr/>
              </p:nvSpPr>
              <p:spPr>
                <a:xfrm>
                  <a:off x="3392280" y="1647720"/>
                  <a:ext cx="14760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" name="Text Box 108"/>
                <p:cNvSpPr/>
                <p:nvPr/>
              </p:nvSpPr>
              <p:spPr>
                <a:xfrm>
                  <a:off x="3124080" y="990360"/>
                  <a:ext cx="3376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n-US" sz="700" spc="-1" strike="noStrike">
                      <a:solidFill>
                        <a:srgbClr val="000000"/>
                      </a:solidFill>
                      <a:latin typeface="Times New Roman"/>
                      <a:ea typeface="Arial"/>
                    </a:rPr>
                    <a:t>Spe</a:t>
                  </a:r>
                  <a:r>
                    <a:rPr b="0" lang="en-US" sz="700" spc="-1" strike="noStrike">
                      <a:solidFill>
                        <a:srgbClr val="000000"/>
                      </a:solidFill>
                      <a:latin typeface="Times New Roman"/>
                      <a:ea typeface="Arial"/>
                    </a:rPr>
                    <a:t>I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" name="Text Box 109"/>
                <p:cNvSpPr/>
                <p:nvPr/>
              </p:nvSpPr>
              <p:spPr>
                <a:xfrm>
                  <a:off x="3466800" y="1554120"/>
                  <a:ext cx="3376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n-US" sz="700" spc="-1" strike="noStrike">
                      <a:solidFill>
                        <a:srgbClr val="000000"/>
                      </a:solidFill>
                      <a:latin typeface="Times New Roman"/>
                      <a:ea typeface="Arial"/>
                    </a:rPr>
                    <a:t>Spe</a:t>
                  </a:r>
                  <a:r>
                    <a:rPr b="0" lang="en-US" sz="700" spc="-1" strike="noStrike">
                      <a:solidFill>
                        <a:srgbClr val="000000"/>
                      </a:solidFill>
                      <a:latin typeface="Times New Roman"/>
                      <a:ea typeface="Arial"/>
                    </a:rPr>
                    <a:t>I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51" name="Text Box 121"/>
              <p:cNvSpPr/>
              <p:nvPr/>
            </p:nvSpPr>
            <p:spPr>
              <a:xfrm>
                <a:off x="3275640" y="1219320"/>
                <a:ext cx="369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tetM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2" name="Group 131"/>
            <p:cNvGrpSpPr/>
            <p:nvPr/>
          </p:nvGrpSpPr>
          <p:grpSpPr>
            <a:xfrm>
              <a:off x="1711440" y="2954520"/>
              <a:ext cx="2436120" cy="1956600"/>
              <a:chOff x="1711440" y="2954520"/>
              <a:chExt cx="2436120" cy="1956600"/>
            </a:xfrm>
          </p:grpSpPr>
          <p:sp>
            <p:nvSpPr>
              <p:cNvPr id="53" name="AutoShape 84"/>
              <p:cNvSpPr/>
              <p:nvPr/>
            </p:nvSpPr>
            <p:spPr>
              <a:xfrm rot="3456600">
                <a:off x="1980720" y="3223800"/>
                <a:ext cx="1417680" cy="1417680"/>
              </a:xfrm>
              <a:custGeom>
                <a:avLst/>
                <a:gdLst>
                  <a:gd name="textAreaLeft" fmla="*/ 261720 w 1417680"/>
                  <a:gd name="textAreaRight" fmla="*/ 1155960 w 1417680"/>
                  <a:gd name="textAreaTop" fmla="*/ 0 h 1417680"/>
                  <a:gd name="textAreaBottom" fmla="*/ 263520 h 141768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6669" y="3098"/>
                    </a:moveTo>
                    <a:cubicBezTo>
                      <a:pt x="7939" y="2417"/>
                      <a:pt x="9358" y="2060"/>
                      <a:pt x="10800" y="2061"/>
                    </a:cubicBezTo>
                    <a:cubicBezTo>
                      <a:pt x="12241" y="2061"/>
                      <a:pt x="13660" y="2417"/>
                      <a:pt x="14930" y="3098"/>
                    </a:cubicBezTo>
                    <a:lnTo>
                      <a:pt x="15904" y="1282"/>
                    </a:lnTo>
                    <a:cubicBezTo>
                      <a:pt x="14334" y="440"/>
                      <a:pt x="12581" y="-1"/>
                      <a:pt x="10799" y="0"/>
                    </a:cubicBezTo>
                    <a:cubicBezTo>
                      <a:pt x="9018" y="0"/>
                      <a:pt x="7265" y="440"/>
                      <a:pt x="5695" y="1282"/>
                    </a:cubicBezTo>
                    <a:lnTo>
                      <a:pt x="6669" y="3098"/>
                    </a:lnTo>
                    <a:close/>
                  </a:path>
                </a:pathLst>
              </a:custGeom>
              <a:blipFill rotWithShape="0">
                <a:blip r:embed="rId2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AutoShape 87"/>
              <p:cNvSpPr/>
              <p:nvPr/>
            </p:nvSpPr>
            <p:spPr>
              <a:xfrm>
                <a:off x="1981080" y="3224160"/>
                <a:ext cx="1417680" cy="1417680"/>
              </a:xfrm>
              <a:custGeom>
                <a:avLst/>
                <a:gdLst>
                  <a:gd name="textAreaLeft" fmla="*/ 207720 w 1417680"/>
                  <a:gd name="textAreaRight" fmla="*/ 1209960 w 1417680"/>
                  <a:gd name="textAreaTop" fmla="*/ 207720 h 1417680"/>
                  <a:gd name="textAreaBottom" fmla="*/ 1209960 h 141768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10800"/>
                    </a:moveTo>
                    <a:cubicBezTo>
                      <a:pt x="0" y="4835"/>
                      <a:pt x="4835" y="0"/>
                      <a:pt x="10800" y="0"/>
                    </a:cubicBezTo>
                    <a:cubicBezTo>
                      <a:pt x="16765" y="0"/>
                      <a:pt x="21600" y="4835"/>
                      <a:pt x="21600" y="10800"/>
                    </a:cubicBezTo>
                    <a:cubicBezTo>
                      <a:pt x="21600" y="16765"/>
                      <a:pt x="16765" y="21600"/>
                      <a:pt x="10800" y="21600"/>
                    </a:cubicBezTo>
                    <a:cubicBezTo>
                      <a:pt x="4835" y="21600"/>
                      <a:pt x="0" y="16765"/>
                      <a:pt x="0" y="10800"/>
                    </a:cubicBezTo>
                    <a:close/>
                    <a:moveTo>
                      <a:pt x="2077" y="10800"/>
                    </a:moveTo>
                    <a:cubicBezTo>
                      <a:pt x="2077" y="15618"/>
                      <a:pt x="5982" y="19523"/>
                      <a:pt x="10800" y="19523"/>
                    </a:cubicBezTo>
                    <a:cubicBezTo>
                      <a:pt x="15618" y="19523"/>
                      <a:pt x="19523" y="15618"/>
                      <a:pt x="19523" y="10800"/>
                    </a:cubicBezTo>
                    <a:cubicBezTo>
                      <a:pt x="19523" y="5982"/>
                      <a:pt x="15618" y="2077"/>
                      <a:pt x="10800" y="2077"/>
                    </a:cubicBezTo>
                    <a:cubicBezTo>
                      <a:pt x="5982" y="2077"/>
                      <a:pt x="2077" y="5982"/>
                      <a:pt x="2077" y="10800"/>
                    </a:cubicBez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AutoShape 88"/>
              <p:cNvSpPr/>
              <p:nvPr/>
            </p:nvSpPr>
            <p:spPr>
              <a:xfrm>
                <a:off x="1981080" y="3224160"/>
                <a:ext cx="1417680" cy="1417680"/>
              </a:xfrm>
              <a:prstGeom prst="pi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10800" bIns="46800" anchor="t" anchorCtr="1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myco-</a:t>
                </a:r>
                <a:r>
                  <a:rPr b="0" i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oriC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Line 90"/>
              <p:cNvSpPr/>
              <p:nvPr/>
            </p:nvSpPr>
            <p:spPr>
              <a:xfrm>
                <a:off x="3047760" y="3319560"/>
                <a:ext cx="147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Line 91"/>
              <p:cNvSpPr/>
              <p:nvPr/>
            </p:nvSpPr>
            <p:spPr>
              <a:xfrm>
                <a:off x="3392280" y="3880080"/>
                <a:ext cx="147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Text Box 95"/>
              <p:cNvSpPr/>
              <p:nvPr/>
            </p:nvSpPr>
            <p:spPr>
              <a:xfrm>
                <a:off x="3124080" y="3222720"/>
                <a:ext cx="3376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7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Spe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I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Text Box 96"/>
              <p:cNvSpPr/>
              <p:nvPr/>
            </p:nvSpPr>
            <p:spPr>
              <a:xfrm>
                <a:off x="3467160" y="3755880"/>
                <a:ext cx="3376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7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Spe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I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AutoShape 99"/>
              <p:cNvSpPr/>
              <p:nvPr/>
            </p:nvSpPr>
            <p:spPr>
              <a:xfrm rot="6622200">
                <a:off x="1980720" y="3224160"/>
                <a:ext cx="1417680" cy="1417680"/>
              </a:xfrm>
              <a:custGeom>
                <a:avLst/>
                <a:gdLst>
                  <a:gd name="textAreaLeft" fmla="*/ 331560 w 1417680"/>
                  <a:gd name="textAreaRight" fmla="*/ 1086120 w 1417680"/>
                  <a:gd name="textAreaTop" fmla="*/ 0 h 1417680"/>
                  <a:gd name="textAreaBottom" fmla="*/ 223920 h 141768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7540" y="2683"/>
                    </a:moveTo>
                    <a:cubicBezTo>
                      <a:pt x="8576" y="2266"/>
                      <a:pt x="9683" y="2052"/>
                      <a:pt x="10800" y="2053"/>
                    </a:cubicBezTo>
                    <a:cubicBezTo>
                      <a:pt x="11916" y="2053"/>
                      <a:pt x="13023" y="2266"/>
                      <a:pt x="14059" y="2683"/>
                    </a:cubicBezTo>
                    <a:lnTo>
                      <a:pt x="14825" y="778"/>
                    </a:lnTo>
                    <a:cubicBezTo>
                      <a:pt x="13545" y="264"/>
                      <a:pt x="12179" y="-1"/>
                      <a:pt x="10799" y="0"/>
                    </a:cubicBezTo>
                    <a:cubicBezTo>
                      <a:pt x="9420" y="0"/>
                      <a:pt x="8054" y="264"/>
                      <a:pt x="6774" y="778"/>
                    </a:cubicBezTo>
                    <a:lnTo>
                      <a:pt x="7540" y="2683"/>
                    </a:lnTo>
                    <a:close/>
                  </a:path>
                </a:pathLst>
              </a:custGeom>
              <a:blipFill rotWithShape="0">
                <a:blip r:embed="rId3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Text Box 111"/>
              <p:cNvSpPr/>
              <p:nvPr/>
            </p:nvSpPr>
            <p:spPr>
              <a:xfrm>
                <a:off x="3275640" y="3451320"/>
                <a:ext cx="369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tetM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Text Box 123"/>
              <p:cNvSpPr/>
              <p:nvPr/>
            </p:nvSpPr>
            <p:spPr>
              <a:xfrm>
                <a:off x="3468600" y="3832200"/>
                <a:ext cx="3376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7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Not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I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Text Box 125"/>
              <p:cNvSpPr/>
              <p:nvPr/>
            </p:nvSpPr>
            <p:spPr>
              <a:xfrm>
                <a:off x="3326400" y="4289400"/>
                <a:ext cx="3222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7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Pst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I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Line 126"/>
              <p:cNvSpPr/>
              <p:nvPr/>
            </p:nvSpPr>
            <p:spPr>
              <a:xfrm>
                <a:off x="3396960" y="3915000"/>
                <a:ext cx="147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Line 127"/>
              <p:cNvSpPr/>
              <p:nvPr/>
            </p:nvSpPr>
            <p:spPr>
              <a:xfrm>
                <a:off x="3220920" y="4408560"/>
                <a:ext cx="147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Text Box 130"/>
              <p:cNvSpPr/>
              <p:nvPr/>
            </p:nvSpPr>
            <p:spPr>
              <a:xfrm>
                <a:off x="3354120" y="4060800"/>
                <a:ext cx="793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Gene fragmen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7" name="Group 149"/>
            <p:cNvGrpSpPr/>
            <p:nvPr/>
          </p:nvGrpSpPr>
          <p:grpSpPr>
            <a:xfrm>
              <a:off x="1711440" y="5193360"/>
              <a:ext cx="2436120" cy="1992240"/>
              <a:chOff x="1711440" y="5193360"/>
              <a:chExt cx="2436120" cy="1992240"/>
            </a:xfrm>
          </p:grpSpPr>
          <p:sp>
            <p:nvSpPr>
              <p:cNvPr id="68" name="AutoShape 100"/>
              <p:cNvSpPr/>
              <p:nvPr/>
            </p:nvSpPr>
            <p:spPr>
              <a:xfrm rot="9793800">
                <a:off x="1980720" y="5462640"/>
                <a:ext cx="1417680" cy="1417680"/>
              </a:xfrm>
              <a:custGeom>
                <a:avLst/>
                <a:gdLst>
                  <a:gd name="textAreaLeft" fmla="*/ 226800 w 1417680"/>
                  <a:gd name="textAreaRight" fmla="*/ 1190880 w 1417680"/>
                  <a:gd name="textAreaTop" fmla="*/ 0 h 1417680"/>
                  <a:gd name="textAreaBottom" fmla="*/ 290520 h 141768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6245" y="3389"/>
                    </a:moveTo>
                    <a:cubicBezTo>
                      <a:pt x="7615" y="2547"/>
                      <a:pt x="9191" y="2101"/>
                      <a:pt x="10800" y="2102"/>
                    </a:cubicBezTo>
                    <a:cubicBezTo>
                      <a:pt x="12408" y="2102"/>
                      <a:pt x="13984" y="2547"/>
                      <a:pt x="15354" y="3389"/>
                    </a:cubicBezTo>
                    <a:lnTo>
                      <a:pt x="16455" y="1598"/>
                    </a:lnTo>
                    <a:cubicBezTo>
                      <a:pt x="14754" y="553"/>
                      <a:pt x="12796" y="-1"/>
                      <a:pt x="10799" y="0"/>
                    </a:cubicBezTo>
                    <a:cubicBezTo>
                      <a:pt x="8803" y="0"/>
                      <a:pt x="6845" y="553"/>
                      <a:pt x="5144" y="1598"/>
                    </a:cubicBezTo>
                    <a:lnTo>
                      <a:pt x="6245" y="3389"/>
                    </a:lnTo>
                    <a:close/>
                  </a:path>
                </a:pathLst>
              </a:custGeom>
              <a:blipFill rotWithShape="0">
                <a:blip r:embed="rId4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Text Box 124"/>
              <p:cNvSpPr/>
              <p:nvPr/>
            </p:nvSpPr>
            <p:spPr>
              <a:xfrm>
                <a:off x="2373840" y="6985080"/>
                <a:ext cx="3222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7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Sal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I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AutoShape 133"/>
              <p:cNvSpPr/>
              <p:nvPr/>
            </p:nvSpPr>
            <p:spPr>
              <a:xfrm rot="3456600">
                <a:off x="1980720" y="5462640"/>
                <a:ext cx="1417680" cy="1417680"/>
              </a:xfrm>
              <a:custGeom>
                <a:avLst/>
                <a:gdLst>
                  <a:gd name="textAreaLeft" fmla="*/ 261720 w 1417680"/>
                  <a:gd name="textAreaRight" fmla="*/ 1155960 w 1417680"/>
                  <a:gd name="textAreaTop" fmla="*/ 0 h 1417680"/>
                  <a:gd name="textAreaBottom" fmla="*/ 263520 h 141768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6669" y="3098"/>
                    </a:moveTo>
                    <a:cubicBezTo>
                      <a:pt x="7939" y="2417"/>
                      <a:pt x="9358" y="2060"/>
                      <a:pt x="10800" y="2061"/>
                    </a:cubicBezTo>
                    <a:cubicBezTo>
                      <a:pt x="12241" y="2061"/>
                      <a:pt x="13660" y="2417"/>
                      <a:pt x="14930" y="3098"/>
                    </a:cubicBezTo>
                    <a:lnTo>
                      <a:pt x="15904" y="1282"/>
                    </a:lnTo>
                    <a:cubicBezTo>
                      <a:pt x="14334" y="440"/>
                      <a:pt x="12581" y="-1"/>
                      <a:pt x="10799" y="0"/>
                    </a:cubicBezTo>
                    <a:cubicBezTo>
                      <a:pt x="9018" y="0"/>
                      <a:pt x="7265" y="440"/>
                      <a:pt x="5695" y="1282"/>
                    </a:cubicBezTo>
                    <a:lnTo>
                      <a:pt x="6669" y="3098"/>
                    </a:lnTo>
                    <a:close/>
                  </a:path>
                </a:pathLst>
              </a:custGeom>
              <a:blipFill rotWithShape="0">
                <a:blip r:embed="rId5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AutoShape 134"/>
              <p:cNvSpPr/>
              <p:nvPr/>
            </p:nvSpPr>
            <p:spPr>
              <a:xfrm>
                <a:off x="1981080" y="5463000"/>
                <a:ext cx="1417680" cy="1417680"/>
              </a:xfrm>
              <a:custGeom>
                <a:avLst/>
                <a:gdLst>
                  <a:gd name="textAreaLeft" fmla="*/ 207720 w 1417680"/>
                  <a:gd name="textAreaRight" fmla="*/ 1209960 w 1417680"/>
                  <a:gd name="textAreaTop" fmla="*/ 207720 h 1417680"/>
                  <a:gd name="textAreaBottom" fmla="*/ 1209960 h 141768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10800"/>
                    </a:moveTo>
                    <a:cubicBezTo>
                      <a:pt x="0" y="4835"/>
                      <a:pt x="4835" y="0"/>
                      <a:pt x="10800" y="0"/>
                    </a:cubicBezTo>
                    <a:cubicBezTo>
                      <a:pt x="16765" y="0"/>
                      <a:pt x="21600" y="4835"/>
                      <a:pt x="21600" y="10800"/>
                    </a:cubicBezTo>
                    <a:cubicBezTo>
                      <a:pt x="21600" y="16765"/>
                      <a:pt x="16765" y="21600"/>
                      <a:pt x="10800" y="21600"/>
                    </a:cubicBezTo>
                    <a:cubicBezTo>
                      <a:pt x="4835" y="21600"/>
                      <a:pt x="0" y="16765"/>
                      <a:pt x="0" y="10800"/>
                    </a:cubicBezTo>
                    <a:close/>
                    <a:moveTo>
                      <a:pt x="2077" y="10800"/>
                    </a:moveTo>
                    <a:cubicBezTo>
                      <a:pt x="2077" y="15618"/>
                      <a:pt x="5982" y="19523"/>
                      <a:pt x="10800" y="19523"/>
                    </a:cubicBezTo>
                    <a:cubicBezTo>
                      <a:pt x="15618" y="19523"/>
                      <a:pt x="19523" y="15618"/>
                      <a:pt x="19523" y="10800"/>
                    </a:cubicBezTo>
                    <a:cubicBezTo>
                      <a:pt x="19523" y="5982"/>
                      <a:pt x="15618" y="2077"/>
                      <a:pt x="10800" y="2077"/>
                    </a:cubicBezTo>
                    <a:cubicBezTo>
                      <a:pt x="5982" y="2077"/>
                      <a:pt x="2077" y="5982"/>
                      <a:pt x="2077" y="10800"/>
                    </a:cubicBez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AutoShape 135"/>
              <p:cNvSpPr/>
              <p:nvPr/>
            </p:nvSpPr>
            <p:spPr>
              <a:xfrm>
                <a:off x="1981080" y="5463000"/>
                <a:ext cx="1417680" cy="1417680"/>
              </a:xfrm>
              <a:prstGeom prst="pi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10800" bIns="46800" anchor="t" anchorCtr="1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myco-</a:t>
                </a:r>
                <a:r>
                  <a:rPr b="0" i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oriC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Line 136"/>
              <p:cNvSpPr/>
              <p:nvPr/>
            </p:nvSpPr>
            <p:spPr>
              <a:xfrm>
                <a:off x="3047760" y="5558040"/>
                <a:ext cx="147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Line 137"/>
              <p:cNvSpPr/>
              <p:nvPr/>
            </p:nvSpPr>
            <p:spPr>
              <a:xfrm>
                <a:off x="3392280" y="6118560"/>
                <a:ext cx="147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Text Box 138"/>
              <p:cNvSpPr/>
              <p:nvPr/>
            </p:nvSpPr>
            <p:spPr>
              <a:xfrm>
                <a:off x="3124080" y="5461200"/>
                <a:ext cx="3376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7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Spe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I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Text Box 139"/>
              <p:cNvSpPr/>
              <p:nvPr/>
            </p:nvSpPr>
            <p:spPr>
              <a:xfrm>
                <a:off x="3467160" y="5994720"/>
                <a:ext cx="3376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7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Spe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I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AutoShape 140"/>
              <p:cNvSpPr/>
              <p:nvPr/>
            </p:nvSpPr>
            <p:spPr>
              <a:xfrm rot="6622200">
                <a:off x="1980720" y="5463000"/>
                <a:ext cx="1417680" cy="1417680"/>
              </a:xfrm>
              <a:custGeom>
                <a:avLst/>
                <a:gdLst>
                  <a:gd name="textAreaLeft" fmla="*/ 331560 w 1417680"/>
                  <a:gd name="textAreaRight" fmla="*/ 1086120 w 1417680"/>
                  <a:gd name="textAreaTop" fmla="*/ 0 h 1417680"/>
                  <a:gd name="textAreaBottom" fmla="*/ 223920 h 141768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7540" y="2683"/>
                    </a:moveTo>
                    <a:cubicBezTo>
                      <a:pt x="8576" y="2266"/>
                      <a:pt x="9683" y="2052"/>
                      <a:pt x="10800" y="2053"/>
                    </a:cubicBezTo>
                    <a:cubicBezTo>
                      <a:pt x="11916" y="2053"/>
                      <a:pt x="13023" y="2266"/>
                      <a:pt x="14059" y="2683"/>
                    </a:cubicBezTo>
                    <a:lnTo>
                      <a:pt x="14825" y="778"/>
                    </a:lnTo>
                    <a:cubicBezTo>
                      <a:pt x="13545" y="264"/>
                      <a:pt x="12179" y="-1"/>
                      <a:pt x="10799" y="0"/>
                    </a:cubicBezTo>
                    <a:cubicBezTo>
                      <a:pt x="9420" y="0"/>
                      <a:pt x="8054" y="264"/>
                      <a:pt x="6774" y="778"/>
                    </a:cubicBezTo>
                    <a:lnTo>
                      <a:pt x="7540" y="2683"/>
                    </a:lnTo>
                    <a:close/>
                  </a:path>
                </a:pathLst>
              </a:custGeom>
              <a:blipFill rotWithShape="0">
                <a:blip r:embed="rId6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Text Box 141"/>
              <p:cNvSpPr/>
              <p:nvPr/>
            </p:nvSpPr>
            <p:spPr>
              <a:xfrm>
                <a:off x="3275640" y="5689800"/>
                <a:ext cx="369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tetM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Text Box 142"/>
              <p:cNvSpPr/>
              <p:nvPr/>
            </p:nvSpPr>
            <p:spPr>
              <a:xfrm>
                <a:off x="3468600" y="6070680"/>
                <a:ext cx="3376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7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Not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I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Text Box 143"/>
              <p:cNvSpPr/>
              <p:nvPr/>
            </p:nvSpPr>
            <p:spPr>
              <a:xfrm>
                <a:off x="3326400" y="6527880"/>
                <a:ext cx="3222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7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Pst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I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Line 144"/>
              <p:cNvSpPr/>
              <p:nvPr/>
            </p:nvSpPr>
            <p:spPr>
              <a:xfrm>
                <a:off x="3396960" y="6153480"/>
                <a:ext cx="147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Line 145"/>
              <p:cNvSpPr/>
              <p:nvPr/>
            </p:nvSpPr>
            <p:spPr>
              <a:xfrm>
                <a:off x="3220920" y="6647040"/>
                <a:ext cx="147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Text Box 146"/>
              <p:cNvSpPr/>
              <p:nvPr/>
            </p:nvSpPr>
            <p:spPr>
              <a:xfrm>
                <a:off x="3354120" y="6299640"/>
                <a:ext cx="793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Gene fragmen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Text Box 147"/>
              <p:cNvSpPr/>
              <p:nvPr/>
            </p:nvSpPr>
            <p:spPr>
              <a:xfrm>
                <a:off x="2815200" y="6832800"/>
                <a:ext cx="374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rec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Line 148"/>
              <p:cNvSpPr/>
              <p:nvPr/>
            </p:nvSpPr>
            <p:spPr>
              <a:xfrm>
                <a:off x="2514600" y="6848640"/>
                <a:ext cx="0" cy="147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6" name="Rectangle 5"/>
            <p:cNvSpPr/>
            <p:nvPr/>
          </p:nvSpPr>
          <p:spPr>
            <a:xfrm>
              <a:off x="907920" y="7137720"/>
              <a:ext cx="5112000" cy="1007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AU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Figure S2</a:t>
              </a:r>
              <a:r>
                <a:rPr b="0" lang="en-AU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 Development of engineered constructs for disrupting gene targets. Internal fragments of the </a:t>
              </a:r>
              <a:r>
                <a:rPr b="0" i="1" lang="en-AU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48 </a:t>
              </a:r>
              <a:r>
                <a:rPr b="0" lang="en-AU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lane 1, 392 bp), </a:t>
              </a:r>
              <a:r>
                <a:rPr b="0" i="1" lang="en-AU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type II restriction endonuclease</a:t>
              </a:r>
              <a:r>
                <a:rPr b="0" lang="en-AU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(lane 2, 462 bp) and </a:t>
              </a:r>
              <a:r>
                <a:rPr b="0" i="1" lang="en-AU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xer1</a:t>
              </a:r>
              <a:r>
                <a:rPr b="0" lang="en-AU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(lane 3, 251 bp) genes were amplified from </a:t>
              </a:r>
              <a:r>
                <a:rPr b="0" i="1" lang="en-AU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. bovis </a:t>
              </a:r>
              <a:r>
                <a:rPr b="0" lang="en-AU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train PG45 with appropriate primers and inserted between the </a:t>
              </a:r>
              <a:r>
                <a:rPr b="0" i="1" lang="en-AU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ot</a:t>
              </a:r>
              <a:r>
                <a:rPr b="0" lang="en-AU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 and </a:t>
              </a:r>
              <a:r>
                <a:rPr b="0" i="1" lang="en-AU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st</a:t>
              </a:r>
              <a:r>
                <a:rPr b="0" lang="en-AU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 sites of the IRR based </a:t>
              </a:r>
              <a:r>
                <a:rPr b="0" i="1" lang="en-AU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oriC </a:t>
              </a:r>
              <a:r>
                <a:rPr b="0" lang="en-AU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lasmid. To promote homologous recombination, the </a:t>
              </a:r>
              <a:r>
                <a:rPr b="0" i="1" lang="en-AU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ecA</a:t>
              </a:r>
              <a:r>
                <a:rPr b="0" lang="en-AU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gene was amplified from </a:t>
              </a:r>
              <a:r>
                <a:rPr b="0" i="1" lang="en-AU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. gallisepticum </a:t>
              </a:r>
              <a:r>
                <a:rPr b="0" lang="en-AU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train S6 and cloned between the </a:t>
              </a:r>
              <a:r>
                <a:rPr b="0" i="1" lang="en-AU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st</a:t>
              </a:r>
              <a:r>
                <a:rPr b="0" lang="en-AU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 and </a:t>
              </a:r>
              <a:r>
                <a:rPr b="0" i="1" lang="en-AU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al</a:t>
              </a:r>
              <a:r>
                <a:rPr b="0" lang="en-AU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 cleavage sites of the construct.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Down Arrow 1"/>
            <p:cNvSpPr/>
            <p:nvPr/>
          </p:nvSpPr>
          <p:spPr>
            <a:xfrm>
              <a:off x="2565360" y="2505240"/>
              <a:ext cx="287280" cy="576000"/>
            </a:xfrm>
            <a:prstGeom prst="downArrow">
              <a:avLst>
                <a:gd name="adj1" fmla="val 50000"/>
                <a:gd name="adj2" fmla="val 50116"/>
              </a:avLst>
            </a:pr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Down Arrow 62"/>
            <p:cNvSpPr/>
            <p:nvPr/>
          </p:nvSpPr>
          <p:spPr>
            <a:xfrm>
              <a:off x="2565360" y="4737240"/>
              <a:ext cx="287280" cy="576000"/>
            </a:xfrm>
            <a:prstGeom prst="downArrow">
              <a:avLst>
                <a:gd name="adj1" fmla="val 50000"/>
                <a:gd name="adj2" fmla="val 50116"/>
              </a:avLst>
            </a:pr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9" name="Group 9"/>
            <p:cNvGrpSpPr/>
            <p:nvPr/>
          </p:nvGrpSpPr>
          <p:grpSpPr>
            <a:xfrm>
              <a:off x="3801960" y="1928880"/>
              <a:ext cx="2072160" cy="1346400"/>
              <a:chOff x="3801960" y="1928880"/>
              <a:chExt cx="2072160" cy="1346400"/>
            </a:xfrm>
          </p:grpSpPr>
          <p:sp>
            <p:nvSpPr>
              <p:cNvPr id="90" name="Straight Connector 111"/>
              <p:cNvSpPr/>
              <p:nvPr/>
            </p:nvSpPr>
            <p:spPr>
              <a:xfrm flipH="1">
                <a:off x="4092120" y="2849400"/>
                <a:ext cx="160200" cy="28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Straight Connector 108"/>
              <p:cNvSpPr/>
              <p:nvPr/>
            </p:nvSpPr>
            <p:spPr>
              <a:xfrm flipH="1">
                <a:off x="4092120" y="2917800"/>
                <a:ext cx="160200" cy="28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Straight Connector 110"/>
              <p:cNvSpPr/>
              <p:nvPr/>
            </p:nvSpPr>
            <p:spPr>
              <a:xfrm flipH="1">
                <a:off x="4092120" y="3031920"/>
                <a:ext cx="160200" cy="28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Straight Connector 109"/>
              <p:cNvSpPr/>
              <p:nvPr/>
            </p:nvSpPr>
            <p:spPr>
              <a:xfrm flipH="1">
                <a:off x="4092120" y="3173400"/>
                <a:ext cx="160200" cy="28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94" name="Group 16"/>
              <p:cNvGrpSpPr/>
              <p:nvPr/>
            </p:nvGrpSpPr>
            <p:grpSpPr>
              <a:xfrm>
                <a:off x="3801960" y="2133360"/>
                <a:ext cx="383400" cy="762840"/>
                <a:chOff x="3801960" y="2133360"/>
                <a:chExt cx="383400" cy="762840"/>
              </a:xfrm>
            </p:grpSpPr>
            <p:sp>
              <p:nvSpPr>
                <p:cNvPr id="95" name="Text Box 5"/>
                <p:cNvSpPr/>
                <p:nvPr/>
              </p:nvSpPr>
              <p:spPr>
                <a:xfrm>
                  <a:off x="3837600" y="2572920"/>
                  <a:ext cx="32544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900" spc="-1" strike="noStrike">
                      <a:solidFill>
                        <a:srgbClr val="000000"/>
                      </a:solidFill>
                      <a:latin typeface="Times New Roman"/>
                      <a:ea typeface="Arial"/>
                    </a:rPr>
                    <a:t>1.5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" name="Text Box 6"/>
                <p:cNvSpPr/>
                <p:nvPr/>
              </p:nvSpPr>
              <p:spPr>
                <a:xfrm>
                  <a:off x="3832920" y="2665080"/>
                  <a:ext cx="32544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900" spc="-1" strike="noStrike">
                      <a:solidFill>
                        <a:srgbClr val="000000"/>
                      </a:solidFill>
                      <a:latin typeface="Times New Roman"/>
                      <a:ea typeface="Arial"/>
                    </a:rPr>
                    <a:t>1.0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" name="Text Box 7"/>
                <p:cNvSpPr/>
                <p:nvPr/>
              </p:nvSpPr>
              <p:spPr>
                <a:xfrm>
                  <a:off x="3832920" y="2485440"/>
                  <a:ext cx="32544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900" spc="-1" strike="noStrike">
                      <a:solidFill>
                        <a:srgbClr val="000000"/>
                      </a:solidFill>
                      <a:latin typeface="Times New Roman"/>
                      <a:ea typeface="Arial"/>
                    </a:rPr>
                    <a:t>2.0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" name="Text Box 12"/>
                <p:cNvSpPr/>
                <p:nvPr/>
              </p:nvSpPr>
              <p:spPr>
                <a:xfrm>
                  <a:off x="3801960" y="2133360"/>
                  <a:ext cx="38340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900" spc="-1" strike="noStrike">
                      <a:solidFill>
                        <a:srgbClr val="000000"/>
                      </a:solidFill>
                      <a:latin typeface="Times New Roman"/>
                      <a:ea typeface="Arial"/>
                    </a:rPr>
                    <a:t>10.0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" name="Text Box 13"/>
                <p:cNvSpPr/>
                <p:nvPr/>
              </p:nvSpPr>
              <p:spPr>
                <a:xfrm>
                  <a:off x="3837600" y="2312640"/>
                  <a:ext cx="32544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900" spc="-1" strike="noStrike">
                      <a:solidFill>
                        <a:srgbClr val="000000"/>
                      </a:solidFill>
                      <a:latin typeface="Times New Roman"/>
                      <a:ea typeface="Arial"/>
                    </a:rPr>
                    <a:t>3.0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" name="Text Box 15"/>
                <p:cNvSpPr/>
                <p:nvPr/>
              </p:nvSpPr>
              <p:spPr>
                <a:xfrm>
                  <a:off x="3837600" y="2399760"/>
                  <a:ext cx="32544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900" spc="-1" strike="noStrike">
                      <a:solidFill>
                        <a:srgbClr val="000000"/>
                      </a:solidFill>
                      <a:latin typeface="Times New Roman"/>
                      <a:ea typeface="Arial"/>
                    </a:rPr>
                    <a:t>2.5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01" name="Straight Connector 65"/>
              <p:cNvSpPr/>
              <p:nvPr/>
            </p:nvSpPr>
            <p:spPr>
              <a:xfrm flipH="1">
                <a:off x="4093560" y="2778120"/>
                <a:ext cx="160200" cy="28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Straight Connector 66"/>
              <p:cNvSpPr/>
              <p:nvPr/>
            </p:nvSpPr>
            <p:spPr>
              <a:xfrm flipH="1">
                <a:off x="4093560" y="2259000"/>
                <a:ext cx="160200" cy="28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Straight Connector 67"/>
              <p:cNvSpPr/>
              <p:nvPr/>
            </p:nvSpPr>
            <p:spPr>
              <a:xfrm flipH="1">
                <a:off x="4093560" y="2468520"/>
                <a:ext cx="160200" cy="28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Straight Connector 68"/>
              <p:cNvSpPr/>
              <p:nvPr/>
            </p:nvSpPr>
            <p:spPr>
              <a:xfrm flipH="1">
                <a:off x="4093560" y="2519280"/>
                <a:ext cx="160200" cy="28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Straight Connector 69"/>
              <p:cNvSpPr/>
              <p:nvPr/>
            </p:nvSpPr>
            <p:spPr>
              <a:xfrm flipH="1">
                <a:off x="4093560" y="2573280"/>
                <a:ext cx="160200" cy="28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Straight Connector 70"/>
              <p:cNvSpPr/>
              <p:nvPr/>
            </p:nvSpPr>
            <p:spPr>
              <a:xfrm flipH="1">
                <a:off x="4093560" y="2651040"/>
                <a:ext cx="160200" cy="28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07" name="Group 118"/>
              <p:cNvGrpSpPr/>
              <p:nvPr/>
            </p:nvGrpSpPr>
            <p:grpSpPr>
              <a:xfrm>
                <a:off x="4874760" y="2816640"/>
                <a:ext cx="999360" cy="405000"/>
                <a:chOff x="4874760" y="2816640"/>
                <a:chExt cx="999360" cy="405000"/>
              </a:xfrm>
            </p:grpSpPr>
            <p:grpSp>
              <p:nvGrpSpPr>
                <p:cNvPr id="108" name="Group 83"/>
                <p:cNvGrpSpPr/>
                <p:nvPr/>
              </p:nvGrpSpPr>
              <p:grpSpPr>
                <a:xfrm>
                  <a:off x="4993560" y="2816640"/>
                  <a:ext cx="880560" cy="405000"/>
                  <a:chOff x="4993560" y="2816640"/>
                  <a:chExt cx="880560" cy="405000"/>
                </a:xfrm>
              </p:grpSpPr>
              <p:sp>
                <p:nvSpPr>
                  <p:cNvPr id="109" name="Text Box 32"/>
                  <p:cNvSpPr/>
                  <p:nvPr/>
                </p:nvSpPr>
                <p:spPr>
                  <a:xfrm>
                    <a:off x="4995000" y="2816640"/>
                    <a:ext cx="53280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000" spc="-1" strike="noStrike">
                        <a:solidFill>
                          <a:srgbClr val="000000"/>
                        </a:solidFill>
                        <a:latin typeface="Times New Roman"/>
                        <a:ea typeface="Arial"/>
                      </a:rPr>
                      <a:t>462 bp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0" name="Text Box 33"/>
                  <p:cNvSpPr/>
                  <p:nvPr/>
                </p:nvSpPr>
                <p:spPr>
                  <a:xfrm>
                    <a:off x="4993560" y="2975400"/>
                    <a:ext cx="53280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000" spc="-1" strike="noStrike">
                        <a:solidFill>
                          <a:srgbClr val="000000"/>
                        </a:solidFill>
                        <a:latin typeface="Times New Roman"/>
                        <a:ea typeface="Arial"/>
                      </a:rPr>
                      <a:t>251 bp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1" name="Text Box 34"/>
                  <p:cNvSpPr/>
                  <p:nvPr/>
                </p:nvSpPr>
                <p:spPr>
                  <a:xfrm>
                    <a:off x="5309280" y="2887920"/>
                    <a:ext cx="56484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000" spc="-1" strike="noStrike">
                        <a:solidFill>
                          <a:srgbClr val="000000"/>
                        </a:solidFill>
                        <a:latin typeface="Times New Roman"/>
                        <a:ea typeface="Arial"/>
                      </a:rPr>
                      <a:t> </a:t>
                    </a:r>
                    <a:r>
                      <a:rPr b="0" lang="en-US" sz="1000" spc="-1" strike="noStrike">
                        <a:solidFill>
                          <a:srgbClr val="000000"/>
                        </a:solidFill>
                        <a:latin typeface="Times New Roman"/>
                        <a:ea typeface="Arial"/>
                      </a:rPr>
                      <a:t>392 bp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12" name="Straight Connector 82"/>
                <p:cNvSpPr/>
                <p:nvPr/>
              </p:nvSpPr>
              <p:spPr>
                <a:xfrm flipH="1">
                  <a:off x="4874760" y="3103560"/>
                  <a:ext cx="158760" cy="288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920" bIns="-43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" name="Straight Connector 83"/>
                <p:cNvSpPr/>
                <p:nvPr/>
              </p:nvSpPr>
              <p:spPr>
                <a:xfrm flipH="1">
                  <a:off x="4874760" y="2960640"/>
                  <a:ext cx="158760" cy="288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920" bIns="-43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" name="Straight Connector 84"/>
                <p:cNvSpPr/>
                <p:nvPr/>
              </p:nvSpPr>
              <p:spPr>
                <a:xfrm flipH="1">
                  <a:off x="4875120" y="3031920"/>
                  <a:ext cx="540000" cy="288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920" bIns="-43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15" name="Group 6"/>
              <p:cNvGrpSpPr/>
              <p:nvPr/>
            </p:nvGrpSpPr>
            <p:grpSpPr>
              <a:xfrm>
                <a:off x="3867480" y="1928880"/>
                <a:ext cx="1151640" cy="1291320"/>
                <a:chOff x="3867480" y="1928880"/>
                <a:chExt cx="1151640" cy="1291320"/>
              </a:xfrm>
            </p:grpSpPr>
            <p:sp>
              <p:nvSpPr>
                <p:cNvPr id="116" name="Rectangle 1028"/>
                <p:cNvSpPr/>
                <p:nvPr/>
              </p:nvSpPr>
              <p:spPr>
                <a:xfrm>
                  <a:off x="3867480" y="1928880"/>
                  <a:ext cx="115164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Times New Roman"/>
                      <a:ea typeface="Arial"/>
                    </a:rPr>
                    <a:t>kbp   M   1   2   3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pic>
              <p:nvPicPr>
                <p:cNvPr id="117" name="Picture 19" descr="P021128"/>
                <p:cNvPicPr/>
                <p:nvPr/>
              </p:nvPicPr>
              <p:blipFill>
                <a:blip r:embed="rId7"/>
                <a:srcRect l="19140" t="7348" r="67536" b="60964"/>
                <a:stretch/>
              </p:blipFill>
              <p:spPr>
                <a:xfrm>
                  <a:off x="4201560" y="2168640"/>
                  <a:ext cx="336600" cy="10515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18" name="Picture 19" descr="P021128"/>
                <p:cNvPicPr/>
                <p:nvPr/>
              </p:nvPicPr>
              <p:blipFill>
                <a:blip r:embed="rId8"/>
                <a:srcRect l="38932" t="7348" r="47448" b="60957"/>
                <a:stretch/>
              </p:blipFill>
              <p:spPr>
                <a:xfrm>
                  <a:off x="4534920" y="2168280"/>
                  <a:ext cx="344160" cy="105192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19" name="Rectangle 5"/>
                <p:cNvSpPr/>
                <p:nvPr/>
              </p:nvSpPr>
              <p:spPr>
                <a:xfrm>
                  <a:off x="4207320" y="2168280"/>
                  <a:ext cx="672840" cy="1044000"/>
                </a:xfrm>
                <a:prstGeom prst="rect">
                  <a:avLst/>
                </a:pr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20" name="Text Box 6"/>
              <p:cNvSpPr/>
              <p:nvPr/>
            </p:nvSpPr>
            <p:spPr>
              <a:xfrm>
                <a:off x="3834720" y="2748960"/>
                <a:ext cx="3254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0.8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Text Box 6"/>
              <p:cNvSpPr/>
              <p:nvPr/>
            </p:nvSpPr>
            <p:spPr>
              <a:xfrm>
                <a:off x="3834720" y="2831760"/>
                <a:ext cx="3254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0.6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Text Box 6"/>
              <p:cNvSpPr/>
              <p:nvPr/>
            </p:nvSpPr>
            <p:spPr>
              <a:xfrm>
                <a:off x="3834720" y="2921760"/>
                <a:ext cx="3254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0.4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Text Box 6"/>
              <p:cNvSpPr/>
              <p:nvPr/>
            </p:nvSpPr>
            <p:spPr>
              <a:xfrm>
                <a:off x="3834720" y="3044160"/>
                <a:ext cx="3254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0.2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4" name="Group 8"/>
            <p:cNvGrpSpPr/>
            <p:nvPr/>
          </p:nvGrpSpPr>
          <p:grpSpPr>
            <a:xfrm>
              <a:off x="3795480" y="4218120"/>
              <a:ext cx="1650960" cy="2030400"/>
              <a:chOff x="3795480" y="4218120"/>
              <a:chExt cx="1650960" cy="2030400"/>
            </a:xfrm>
          </p:grpSpPr>
          <p:pic>
            <p:nvPicPr>
              <p:cNvPr id="125" name="Picture 88" descr="P021993"/>
              <p:cNvPicPr/>
              <p:nvPr/>
            </p:nvPicPr>
            <p:blipFill>
              <a:blip r:embed="rId9"/>
              <a:srcRect l="26916" t="0" r="61813" b="65223"/>
              <a:stretch/>
            </p:blipFill>
            <p:spPr>
              <a:xfrm>
                <a:off x="4263480" y="4488480"/>
                <a:ext cx="533160" cy="17524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26" name="Rectangle 1028"/>
              <p:cNvSpPr/>
              <p:nvPr/>
            </p:nvSpPr>
            <p:spPr>
              <a:xfrm>
                <a:off x="3807000" y="4218120"/>
                <a:ext cx="1062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kbp       M   </a:t>
                </a:r>
                <a:r>
                  <a:rPr b="0" i="1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recA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TextBox 50"/>
              <p:cNvSpPr/>
              <p:nvPr/>
            </p:nvSpPr>
            <p:spPr>
              <a:xfrm>
                <a:off x="4881600" y="5219280"/>
                <a:ext cx="5648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.6 kbp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28" name="Group 1"/>
              <p:cNvGrpSpPr/>
              <p:nvPr/>
            </p:nvGrpSpPr>
            <p:grpSpPr>
              <a:xfrm>
                <a:off x="3795480" y="4729680"/>
                <a:ext cx="452160" cy="921240"/>
                <a:chOff x="3795480" y="4729680"/>
                <a:chExt cx="452160" cy="921240"/>
              </a:xfrm>
            </p:grpSpPr>
            <p:grpSp>
              <p:nvGrpSpPr>
                <p:cNvPr id="129" name="Group 16"/>
                <p:cNvGrpSpPr/>
                <p:nvPr/>
              </p:nvGrpSpPr>
              <p:grpSpPr>
                <a:xfrm>
                  <a:off x="3795480" y="4729680"/>
                  <a:ext cx="383400" cy="921240"/>
                  <a:chOff x="3795480" y="4729680"/>
                  <a:chExt cx="383400" cy="921240"/>
                </a:xfrm>
              </p:grpSpPr>
              <p:sp>
                <p:nvSpPr>
                  <p:cNvPr id="130" name="Text Box 5"/>
                  <p:cNvSpPr/>
                  <p:nvPr/>
                </p:nvSpPr>
                <p:spPr>
                  <a:xfrm>
                    <a:off x="3822480" y="5243760"/>
                    <a:ext cx="325440" cy="2311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900" spc="-1" strike="noStrike">
                        <a:solidFill>
                          <a:srgbClr val="000000"/>
                        </a:solidFill>
                        <a:latin typeface="Times New Roman"/>
                        <a:ea typeface="Arial"/>
                      </a:rPr>
                      <a:t>1.5</a:t>
                    </a:r>
                    <a:endParaRPr b="0" lang="en-US" sz="9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1" name="Text Box 6"/>
                  <p:cNvSpPr/>
                  <p:nvPr/>
                </p:nvSpPr>
                <p:spPr>
                  <a:xfrm>
                    <a:off x="3827160" y="5419800"/>
                    <a:ext cx="325440" cy="2311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900" spc="-1" strike="noStrike">
                        <a:solidFill>
                          <a:srgbClr val="000000"/>
                        </a:solidFill>
                        <a:latin typeface="Times New Roman"/>
                        <a:ea typeface="Arial"/>
                      </a:rPr>
                      <a:t>1.0</a:t>
                    </a:r>
                    <a:endParaRPr b="0" lang="en-US" sz="9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2" name="Text Box 7"/>
                  <p:cNvSpPr/>
                  <p:nvPr/>
                </p:nvSpPr>
                <p:spPr>
                  <a:xfrm>
                    <a:off x="3822480" y="5118120"/>
                    <a:ext cx="325440" cy="2311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900" spc="-1" strike="noStrike">
                        <a:solidFill>
                          <a:srgbClr val="000000"/>
                        </a:solidFill>
                        <a:latin typeface="Times New Roman"/>
                        <a:ea typeface="Arial"/>
                      </a:rPr>
                      <a:t>2.0</a:t>
                    </a:r>
                    <a:endParaRPr b="0" lang="en-US" sz="9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3" name="Text Box 12"/>
                  <p:cNvSpPr/>
                  <p:nvPr/>
                </p:nvSpPr>
                <p:spPr>
                  <a:xfrm>
                    <a:off x="3795480" y="4729680"/>
                    <a:ext cx="383400" cy="2311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900" spc="-1" strike="noStrike">
                        <a:solidFill>
                          <a:srgbClr val="000000"/>
                        </a:solidFill>
                        <a:latin typeface="Times New Roman"/>
                        <a:ea typeface="Arial"/>
                      </a:rPr>
                      <a:t>10.0</a:t>
                    </a:r>
                    <a:endParaRPr b="0" lang="en-US" sz="9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34" name="Straight Connector 96"/>
                <p:cNvSpPr/>
                <p:nvPr/>
              </p:nvSpPr>
              <p:spPr>
                <a:xfrm flipH="1">
                  <a:off x="4087440" y="5543280"/>
                  <a:ext cx="160200" cy="288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920" bIns="-43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" name="Straight Connector 97"/>
                <p:cNvSpPr/>
                <p:nvPr/>
              </p:nvSpPr>
              <p:spPr>
                <a:xfrm flipH="1">
                  <a:off x="4087440" y="4855680"/>
                  <a:ext cx="160200" cy="288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920" bIns="-43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6" name="Straight Connector 100"/>
                <p:cNvSpPr/>
                <p:nvPr/>
              </p:nvSpPr>
              <p:spPr>
                <a:xfrm flipH="1">
                  <a:off x="4087440" y="5236920"/>
                  <a:ext cx="160200" cy="288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920" bIns="-43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7" name="Straight Connector 101"/>
                <p:cNvSpPr/>
                <p:nvPr/>
              </p:nvSpPr>
              <p:spPr>
                <a:xfrm flipH="1">
                  <a:off x="4087440" y="5362200"/>
                  <a:ext cx="160200" cy="288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920" bIns="-43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38" name="Straight Connector 116"/>
              <p:cNvSpPr/>
              <p:nvPr/>
            </p:nvSpPr>
            <p:spPr>
              <a:xfrm flipH="1">
                <a:off x="4797000" y="5359320"/>
                <a:ext cx="158760" cy="288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Rectangle 7"/>
              <p:cNvSpPr/>
              <p:nvPr/>
            </p:nvSpPr>
            <p:spPr>
              <a:xfrm>
                <a:off x="4257000" y="4484160"/>
                <a:ext cx="539640" cy="176436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1-22T12:26:48Z</dcterms:created>
  <dc:creator>HP</dc:creator>
  <dc:description/>
  <dc:language>en-US</dc:language>
  <cp:lastModifiedBy>Danielle Siegler</cp:lastModifiedBy>
  <dcterms:modified xsi:type="dcterms:W3CDTF">2015-03-26T16:47:21Z</dcterms:modified>
  <cp:revision>7</cp:revision>
  <dc:subject/>
  <dc:title>Slide 1</dc:title>
</cp:coreProperties>
</file>